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96" r:id="rId2"/>
    <p:sldId id="297" r:id="rId3"/>
    <p:sldId id="298" r:id="rId4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588" autoAdjust="0"/>
    <p:restoredTop sz="94624" autoAdjust="0"/>
  </p:normalViewPr>
  <p:slideViewPr>
    <p:cSldViewPr>
      <p:cViewPr>
        <p:scale>
          <a:sx n="100" d="100"/>
          <a:sy n="100" d="100"/>
        </p:scale>
        <p:origin x="-1134" y="32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14FD3D-AA15-431C-8C46-E6E73DF73A5A}" type="datetimeFigureOut">
              <a:rPr lang="en-US" smtClean="0"/>
              <a:pPr/>
              <a:t>6/27/2020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98273E-3170-446A-B475-5E7C0527FE86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6/2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09616" y="1524003"/>
          <a:ext cx="5486399" cy="2103120"/>
        </p:xfrm>
        <a:graphic>
          <a:graphicData uri="http://schemas.openxmlformats.org/drawingml/2006/table">
            <a:tbl>
              <a:tblPr/>
              <a:tblGrid>
                <a:gridCol w="833250"/>
                <a:gridCol w="309749"/>
                <a:gridCol w="304800"/>
                <a:gridCol w="304800"/>
                <a:gridCol w="304800"/>
                <a:gridCol w="304800"/>
                <a:gridCol w="304800"/>
                <a:gridCol w="152400"/>
                <a:gridCol w="838200"/>
                <a:gridCol w="304800"/>
                <a:gridCol w="304800"/>
                <a:gridCol w="304800"/>
                <a:gridCol w="304800"/>
                <a:gridCol w="304800"/>
                <a:gridCol w="304800"/>
              </a:tblGrid>
              <a:tr h="52578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Terminal electron acceptor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C- source utilization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1</a:t>
                      </a:r>
                      <a:endParaRPr lang="en-IN" sz="1000" i="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endParaRPr lang="en-IN" sz="1000" i="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endParaRPr lang="en-IN" sz="1000" i="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</a:t>
                      </a:r>
                      <a:endParaRPr lang="en-IN" sz="1000" i="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</a:t>
                      </a:r>
                      <a:endParaRPr lang="en-IN" sz="1000" i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i="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</a:t>
                      </a:r>
                      <a:endParaRPr lang="en-IN" sz="1000" i="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s</a:t>
                      </a:r>
                      <a:r>
                        <a:rPr lang="en-US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5+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DL-lact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O</a:t>
                      </a:r>
                      <a:r>
                        <a:rPr lang="en-US" sz="1000" baseline="-25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4</a:t>
                      </a:r>
                      <a:r>
                        <a:rPr lang="en-US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-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i-inositol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</a:t>
                      </a:r>
                      <a:r>
                        <a:rPr lang="en-IN" sz="1000" baseline="-25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</a:t>
                      </a: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O</a:t>
                      </a:r>
                      <a:r>
                        <a:rPr lang="en-IN" sz="1000" baseline="-25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r>
                        <a:rPr lang="en-IN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2-</a:t>
                      </a:r>
                      <a:endParaRPr lang="en-IN" sz="1000" baseline="-25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cetate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Fe</a:t>
                      </a:r>
                      <a:r>
                        <a:rPr lang="en-IN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+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lucose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O</a:t>
                      </a:r>
                      <a:r>
                        <a:rPr lang="en-US" sz="1000" baseline="-25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3</a:t>
                      </a:r>
                      <a:r>
                        <a:rPr lang="en-US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pyruvate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e</a:t>
                      </a:r>
                      <a:r>
                        <a:rPr lang="en-IN" sz="1000" baseline="30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6+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r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r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r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glutamate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D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r</a:t>
                      </a:r>
                      <a:r>
                        <a:rPr lang="en-IN" sz="100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affinose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</a:t>
                      </a: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erine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75260"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err="1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s</a:t>
                      </a:r>
                      <a:r>
                        <a:rPr lang="en-IN" sz="1000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uccin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Times New Roman" pitchFamily="18" charset="0"/>
                        <a:ea typeface="Times New Roman"/>
                        <a:cs typeface="Times New Roman" pitchFamily="18" charset="0"/>
                      </a:endParaRP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+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-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 pitchFamily="18" charset="0"/>
                          <a:ea typeface="Times New Roman"/>
                          <a:cs typeface="Times New Roman" pitchFamily="18" charset="0"/>
                        </a:rPr>
                        <a:t>nr</a:t>
                      </a:r>
                    </a:p>
                  </a:txBody>
                  <a:tcPr marL="45745" marR="45745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34817" name="Rectangle 1"/>
          <p:cNvSpPr>
            <a:spLocks noChangeArrowheads="1"/>
          </p:cNvSpPr>
          <p:nvPr/>
        </p:nvSpPr>
        <p:spPr bwMode="auto">
          <a:xfrm>
            <a:off x="533400" y="914400"/>
            <a:ext cx="579120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upplementary Table </a:t>
            </a:r>
            <a:r>
              <a:rPr lang="en-US" sz="1000" b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1</a:t>
            </a:r>
            <a:r>
              <a:rPr kumimoji="0" lang="en-US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: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Terminal electron acceptor and C-source utilization properties of </a:t>
            </a:r>
            <a:r>
              <a:rPr kumimoji="0" lang="en-US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i="1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</a:t>
            </a:r>
            <a:r>
              <a:rPr kumimoji="0" lang="en-US" sz="10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train 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IIJ3-1 and other  </a:t>
            </a:r>
            <a:r>
              <a:rPr kumimoji="0" lang="en-US" sz="10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acillus</a:t>
            </a:r>
            <a:r>
              <a: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p. reported to be As resistant.</a:t>
            </a:r>
            <a:endParaRPr kumimoji="0" lang="en-US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33400" y="3714690"/>
            <a:ext cx="56388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0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trains 1.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S</a:t>
            </a:r>
            <a:r>
              <a:rPr lang="en-IN" sz="1000" dirty="0" smtClean="0">
                <a:latin typeface="Times New Roman" pitchFamily="18" charset="0"/>
                <a:cs typeface="Times New Roman" pitchFamily="18" charset="0"/>
              </a:rPr>
              <a:t>train IIIJ3-1(T)</a:t>
            </a:r>
            <a:r>
              <a:rPr lang="en-US" sz="1000" baseline="30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</a:t>
            </a:r>
            <a:r>
              <a:rPr lang="en-US" sz="1000" dirty="0" smtClean="0"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present study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);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.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. </a:t>
            </a:r>
            <a:r>
              <a:rPr lang="en-US" sz="1000" i="1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rsenicoselenatis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3.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. </a:t>
            </a:r>
            <a:r>
              <a:rPr lang="en-US" sz="1000" i="1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selenatireducens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(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2,3)- [46]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;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4.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. arsenicus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[36]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;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5. 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. </a:t>
            </a:r>
            <a:r>
              <a:rPr lang="en-US" sz="1000" i="1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barbaricus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[58];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6.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B. </a:t>
            </a:r>
            <a:r>
              <a:rPr lang="en-US" sz="1000" i="1" dirty="0" err="1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indicus</a:t>
            </a:r>
            <a:r>
              <a:rPr lang="en-US" sz="1000" i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 </a:t>
            </a:r>
            <a:r>
              <a:rPr lang="en-US" sz="1000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[37]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838200" y="1219201"/>
          <a:ext cx="5257800" cy="4979059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2278380"/>
                <a:gridCol w="922020"/>
                <a:gridCol w="2057400"/>
              </a:tblGrid>
              <a:tr h="250723">
                <a:tc gridSpan="3"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Arsenate 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reductase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icroorganis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K</a:t>
                      </a:r>
                      <a:r>
                        <a:rPr lang="en-US" sz="1000" baseline="-25000" dirty="0" smtClean="0">
                          <a:latin typeface="Times New Roman" pitchFamily="18" charset="0"/>
                          <a:cs typeface="Times New Roman" pitchFamily="18" charset="0"/>
                        </a:rPr>
                        <a:t>m </a:t>
                      </a:r>
                      <a:r>
                        <a:rPr lang="en-US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(</a:t>
                      </a:r>
                      <a:r>
                        <a:rPr lang="en-US" sz="1000" baseline="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</a:t>
                      </a:r>
                      <a:r>
                        <a:rPr lang="en-US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endParaRPr lang="en-IN" sz="1000" baseline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r>
                        <a:rPr lang="en-US" sz="1000" baseline="-25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ax</a:t>
                      </a:r>
                      <a:endParaRPr lang="en-IN" sz="10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417871">
                <a:tc>
                  <a:txBody>
                    <a:bodyPr/>
                    <a:lstStyle/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S</a:t>
                      </a:r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train IIIJ3-1(T) 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# *</a:t>
                      </a:r>
                      <a:endParaRPr lang="en-IN" sz="1000" i="1" baseline="30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0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0.41 nM</a:t>
                      </a:r>
                      <a:r>
                        <a:rPr lang="en-IN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 of cells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417871">
                <a:tc>
                  <a:txBody>
                    <a:bodyPr/>
                    <a:lstStyle/>
                    <a:p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ynechocystis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sp.</a:t>
                      </a:r>
                      <a:r>
                        <a:rPr lang="en-US" sz="1000" i="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strain </a:t>
                      </a:r>
                    </a:p>
                    <a:p>
                      <a:r>
                        <a:rPr lang="en-US" sz="1000" i="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PCC 6803 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$$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.25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3.1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417871">
                <a:tc>
                  <a:txBody>
                    <a:bodyPr/>
                    <a:lstStyle/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Escherichia coli </a:t>
                      </a:r>
                    </a:p>
                    <a:p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plasmid R773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8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0.8-1.5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396240">
                <a:tc>
                  <a:txBody>
                    <a:bodyPr/>
                    <a:lstStyle/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Staphylococcus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ureus</a:t>
                      </a:r>
                      <a:endParaRPr lang="en-US" sz="1000" i="1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plasmid p1258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0.068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4.5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43840">
                <a:tc>
                  <a:txBody>
                    <a:bodyPr/>
                    <a:lstStyle/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Pseudomonas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tutzeri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$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0.40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5952 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U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43840">
                <a:tc>
                  <a:txBody>
                    <a:bodyPr/>
                    <a:lstStyle/>
                    <a:p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Saccharomyces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cerevisiae</a:t>
                      </a:r>
                      <a:r>
                        <a:rPr lang="en-US" sz="1000" i="1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Acr2p</a:t>
                      </a:r>
                      <a:endParaRPr lang="en-IN" sz="1000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35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0.3-0.5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0723">
                <a:tc gridSpan="3">
                  <a:txBody>
                    <a:bodyPr/>
                    <a:lstStyle/>
                    <a:p>
                      <a:r>
                        <a:rPr lang="en-US" sz="1000" b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rsenite</a:t>
                      </a:r>
                      <a:r>
                        <a:rPr lang="en-US" sz="1000" b="1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b="1" baseline="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oxidase</a:t>
                      </a:r>
                      <a:endParaRPr lang="en-IN" sz="10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IN" sz="12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icroorganis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K</a:t>
                      </a:r>
                      <a:r>
                        <a:rPr lang="en-US" sz="1000" baseline="-25000" dirty="0" smtClean="0">
                          <a:latin typeface="Times New Roman" pitchFamily="18" charset="0"/>
                          <a:cs typeface="Times New Roman" pitchFamily="18" charset="0"/>
                        </a:rPr>
                        <a:t>m </a:t>
                      </a:r>
                      <a:endParaRPr lang="en-IN" sz="1000" baseline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V</a:t>
                      </a:r>
                      <a:r>
                        <a:rPr lang="en-US" sz="1000" baseline="-25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ax</a:t>
                      </a:r>
                      <a:endParaRPr lang="en-IN" sz="10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41787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Strain IIIJ3-1(T) 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# *</a:t>
                      </a:r>
                      <a:endParaRPr lang="en-IN" sz="1000" i="1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2.8 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8.3 </a:t>
                      </a: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nM</a:t>
                      </a:r>
                      <a:r>
                        <a:rPr lang="en-IN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min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mgcells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Pseudomonas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rsenoxydans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450 µ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00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mg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Nh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lcaligenes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faecalis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450 µ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0.05 µ</a:t>
                      </a:r>
                      <a:r>
                        <a:rPr lang="en-US" sz="1000" dirty="0" err="1" smtClean="0">
                          <a:latin typeface="Times New Roman" pitchFamily="18" charset="0"/>
                          <a:cs typeface="Times New Roman" pitchFamily="18" charset="0"/>
                        </a:rPr>
                        <a:t>molmgprotein</a:t>
                      </a:r>
                      <a:r>
                        <a:rPr lang="en-IN" sz="1000" baseline="3000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smtClean="0">
                          <a:latin typeface="Times New Roman" pitchFamily="18" charset="0"/>
                          <a:cs typeface="Times New Roman" pitchFamily="18" charset="0"/>
                        </a:rPr>
                        <a:t>min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lcaligenes</a:t>
                      </a:r>
                      <a:r>
                        <a:rPr lang="en-US" sz="1000" i="1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strain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540 µ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6.7</a:t>
                      </a:r>
                      <a:r>
                        <a:rPr lang="en-US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µlO</a:t>
                      </a:r>
                      <a:r>
                        <a:rPr lang="en-US" sz="1000" baseline="-25000" dirty="0" smtClean="0"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min</a:t>
                      </a:r>
                      <a:r>
                        <a:rPr lang="en-US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250723">
                <a:tc>
                  <a:txBody>
                    <a:bodyPr/>
                    <a:lstStyle/>
                    <a:p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Seawater</a:t>
                      </a:r>
                      <a:r>
                        <a:rPr lang="en-US" sz="1000" i="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consortium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IN" sz="1000" i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70-144 µM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3.6 - 9.2 µMhr</a:t>
                      </a:r>
                      <a:r>
                        <a:rPr lang="en-US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  <a:tr h="417871">
                <a:tc>
                  <a:txBody>
                    <a:bodyPr/>
                    <a:lstStyle/>
                    <a:p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grobacterium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i="1" dirty="0" err="1" smtClean="0">
                          <a:latin typeface="Times New Roman" pitchFamily="18" charset="0"/>
                          <a:cs typeface="Times New Roman" pitchFamily="18" charset="0"/>
                        </a:rPr>
                        <a:t>albertimagni</a:t>
                      </a:r>
                      <a:r>
                        <a:rPr lang="en-US" sz="1000" i="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**</a:t>
                      </a:r>
                      <a:endParaRPr lang="en-US" sz="1000" i="1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r>
                        <a:rPr lang="en-US" sz="1000" i="0" dirty="0" smtClean="0">
                          <a:latin typeface="Times New Roman" pitchFamily="18" charset="0"/>
                          <a:cs typeface="Times New Roman" pitchFamily="18" charset="0"/>
                        </a:rPr>
                        <a:t>Strain AOL15</a:t>
                      </a:r>
                      <a:r>
                        <a:rPr lang="en-US" sz="1000" i="1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endParaRPr lang="en-IN" sz="1000" i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3.4 </a:t>
                      </a:r>
                      <a:r>
                        <a:rPr lang="en-US" sz="1000" u="sng" dirty="0" smtClean="0">
                          <a:latin typeface="Times New Roman" pitchFamily="18" charset="0"/>
                          <a:cs typeface="Times New Roman" pitchFamily="18" charset="0"/>
                        </a:rPr>
                        <a:t>+ </a:t>
                      </a:r>
                      <a:r>
                        <a:rPr lang="en-US" sz="1000" u="none" dirty="0" smtClean="0">
                          <a:latin typeface="Times New Roman" pitchFamily="18" charset="0"/>
                          <a:cs typeface="Times New Roman" pitchFamily="18" charset="0"/>
                        </a:rPr>
                        <a:t>2.2 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µM</a:t>
                      </a:r>
                      <a:endParaRPr lang="en-IN" sz="1000" u="non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1.81</a:t>
                      </a:r>
                      <a:r>
                        <a:rPr lang="en-IN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x 10</a:t>
                      </a:r>
                      <a:r>
                        <a:rPr lang="en-IN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2</a:t>
                      </a:r>
                      <a:r>
                        <a:rPr lang="en-IN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>µmolcell</a:t>
                      </a:r>
                      <a:r>
                        <a:rPr lang="en-US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US" sz="10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min</a:t>
                      </a:r>
                      <a:r>
                        <a:rPr lang="en-US" sz="10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-1</a:t>
                      </a:r>
                      <a: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  <a:t/>
                      </a:r>
                      <a:br>
                        <a:rPr lang="en-IN" sz="1000" dirty="0" smtClean="0">
                          <a:latin typeface="Times New Roman" pitchFamily="18" charset="0"/>
                          <a:cs typeface="Times New Roman" pitchFamily="18" charset="0"/>
                        </a:rPr>
                      </a:br>
                      <a:endParaRPr lang="en-IN" sz="10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62000" y="605135"/>
            <a:ext cx="5562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ry Table 2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: Comparative study of kinetic parameters for aerobic As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5+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reduction and As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3+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oxidation by 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rain IIIJ3-1(T) and other related bacteria</a:t>
            </a:r>
            <a:endParaRPr lang="en-IN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762000" y="6248400"/>
            <a:ext cx="54864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# 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This study, 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*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resting cells, 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**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hole cells, 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$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cell free extract, </a:t>
            </a:r>
            <a:r>
              <a:rPr lang="en-US" sz="1000" baseline="30000" dirty="0" smtClean="0">
                <a:latin typeface="Times New Roman" pitchFamily="18" charset="0"/>
                <a:cs typeface="Times New Roman" pitchFamily="18" charset="0"/>
              </a:rPr>
              <a:t>$$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purified protein product. Data taken from 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[68, 85].</a:t>
            </a:r>
            <a:endParaRPr lang="en-IN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752600" y="914400"/>
            <a:ext cx="2971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b"/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Supplementary Table 3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IN" sz="1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∆</a:t>
            </a:r>
            <a:r>
              <a:rPr lang="en-IN" sz="1000" dirty="0" err="1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G</a:t>
            </a:r>
            <a:r>
              <a:rPr lang="en-IN" sz="1000" baseline="-25000" dirty="0" err="1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f</a:t>
            </a:r>
            <a:r>
              <a:rPr lang="en-IN" sz="1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° values for various terminal e</a:t>
            </a:r>
            <a:r>
              <a:rPr lang="en-IN" sz="1000" baseline="30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-</a:t>
            </a:r>
            <a:r>
              <a:rPr lang="en-IN" sz="1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acceptors with lactate as e</a:t>
            </a:r>
            <a:r>
              <a:rPr lang="en-IN" sz="1000" baseline="30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-</a:t>
            </a:r>
            <a:r>
              <a:rPr lang="en-IN" sz="1000" dirty="0" smtClean="0">
                <a:solidFill>
                  <a:srgbClr val="000000"/>
                </a:solidFill>
                <a:latin typeface="Times New Roman" pitchFamily="18" charset="0"/>
                <a:ea typeface="Times New Roman"/>
                <a:cs typeface="Times New Roman" pitchFamily="18" charset="0"/>
              </a:rPr>
              <a:t> donor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 </a:t>
            </a:r>
            <a:endParaRPr lang="en-IN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828816" y="1371601"/>
          <a:ext cx="2743199" cy="986135"/>
        </p:xfrm>
        <a:graphic>
          <a:graphicData uri="http://schemas.openxmlformats.org/drawingml/2006/table">
            <a:tbl>
              <a:tblPr/>
              <a:tblGrid>
                <a:gridCol w="838200"/>
                <a:gridCol w="737680"/>
                <a:gridCol w="1167319"/>
              </a:tblGrid>
              <a:tr h="346349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e</a:t>
                      </a:r>
                      <a:r>
                        <a:rPr lang="en-IN" sz="1000" b="1" baseline="30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- </a:t>
                      </a: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donor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e</a:t>
                      </a:r>
                      <a:r>
                        <a:rPr lang="en-IN" sz="1000" b="1" baseline="30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- </a:t>
                      </a: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cceptor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b="1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∆</a:t>
                      </a:r>
                      <a:r>
                        <a:rPr lang="en-IN" sz="1000" b="1" dirty="0" err="1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G</a:t>
                      </a:r>
                      <a:r>
                        <a:rPr lang="en-IN" sz="1000" b="1" baseline="-25000" dirty="0" err="1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f</a:t>
                      </a:r>
                      <a:r>
                        <a:rPr lang="en-IN" sz="1000" b="1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°/mol </a:t>
                      </a:r>
                      <a:r>
                        <a:rPr lang="en-IN" sz="1000" b="1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act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02464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act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As</a:t>
                      </a:r>
                      <a:r>
                        <a:rPr lang="en-IN" sz="1000" baseline="30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5+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–172 kJ</a:t>
                      </a:r>
                      <a:endParaRPr lang="en-IN" sz="100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866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act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 SO</a:t>
                      </a:r>
                      <a:r>
                        <a:rPr lang="en-IN" sz="1000" baseline="-25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r>
                        <a:rPr lang="en-IN" sz="1000" baseline="30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2-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–89 kJ</a:t>
                      </a:r>
                      <a:endParaRPr lang="en-IN" sz="100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218661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lactate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NO</a:t>
                      </a:r>
                      <a:r>
                        <a:rPr lang="en-IN" sz="1000" baseline="-25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r>
                        <a:rPr lang="en-IN" sz="1000" baseline="30000" dirty="0" smtClean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-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000" dirty="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  <a:cs typeface="Times New Roman"/>
                        </a:rPr>
                        <a:t> –231.3 kJ</a:t>
                      </a:r>
                      <a:endParaRPr lang="en-IN" sz="1000" dirty="0">
                        <a:solidFill>
                          <a:srgbClr val="000000"/>
                        </a:solidFill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54</TotalTime>
  <Words>435</Words>
  <Application>Microsoft Office PowerPoint</Application>
  <PresentationFormat>A4 Paper (210x297 mm)</PresentationFormat>
  <Paragraphs>184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oma</dc:creator>
  <cp:lastModifiedBy>ADMINSTRATOR</cp:lastModifiedBy>
  <cp:revision>141</cp:revision>
  <dcterms:created xsi:type="dcterms:W3CDTF">2006-08-16T00:00:00Z</dcterms:created>
  <dcterms:modified xsi:type="dcterms:W3CDTF">2020-06-27T11:27:08Z</dcterms:modified>
</cp:coreProperties>
</file>